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5ECFF4-6AF3-4347-955D-EACF3851E9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8779A-DF18-4310-883B-684280D9CC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D42AA-C1DB-4777-91AD-104CFEAB5D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3334E-D257-4CA8-BBCB-090EC2E97B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3BD33-162E-47D7-9777-E5A50506CB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17865C-F5F7-471A-8724-05DB1CF1BA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3E5FCF-4A95-45EA-8C58-2F5266B3EC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828C7-6DB0-41D4-81E1-0A1B4C1040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ACE33-5438-413E-9D01-B1347B030A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4BBD43-B7ED-41B4-9ACA-B6C90249F7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62266-ECBC-472F-B442-A18F0568E9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238501-C56E-495A-A3EC-1C02CE8225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FFAA63-B4F0-49F9-91E7-6E822B411825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직사각형 37"/>
          <p:cNvSpPr/>
          <p:nvPr/>
        </p:nvSpPr>
        <p:spPr>
          <a:xfrm>
            <a:off x="782640" y="4214880"/>
            <a:ext cx="3770280" cy="1044360"/>
          </a:xfrm>
          <a:prstGeom prst="rect">
            <a:avLst/>
          </a:prstGeom>
          <a:solidFill>
            <a:srgbClr val="d9d9d9">
              <a:alpha val="8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직선 연결선 23"/>
          <p:cNvSpPr/>
          <p:nvPr/>
        </p:nvSpPr>
        <p:spPr>
          <a:xfrm>
            <a:off x="2647800" y="876240"/>
            <a:ext cx="180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직선 연결선 24"/>
          <p:cNvSpPr/>
          <p:nvPr/>
        </p:nvSpPr>
        <p:spPr>
          <a:xfrm>
            <a:off x="6470640" y="876240"/>
            <a:ext cx="180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44" name="Group 1"/>
          <p:cNvGrpSpPr/>
          <p:nvPr/>
        </p:nvGrpSpPr>
        <p:grpSpPr>
          <a:xfrm>
            <a:off x="782640" y="696960"/>
            <a:ext cx="7523280" cy="5622840"/>
            <a:chOff x="782640" y="696960"/>
            <a:chExt cx="7523280" cy="5622840"/>
          </a:xfrm>
        </p:grpSpPr>
        <p:sp>
          <p:nvSpPr>
            <p:cNvPr id="45" name="직선 연결선 15"/>
            <p:cNvSpPr/>
            <p:nvPr/>
          </p:nvSpPr>
          <p:spPr>
            <a:xfrm>
              <a:off x="782640" y="696960"/>
              <a:ext cx="752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6" name="직선 연결선 16"/>
            <p:cNvSpPr/>
            <p:nvPr/>
          </p:nvSpPr>
          <p:spPr>
            <a:xfrm>
              <a:off x="782640" y="1054080"/>
              <a:ext cx="7523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7" name="직선 연결선 17"/>
            <p:cNvSpPr/>
            <p:nvPr/>
          </p:nvSpPr>
          <p:spPr>
            <a:xfrm>
              <a:off x="782640" y="2108160"/>
              <a:ext cx="752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8" name="직선 연결선 18"/>
            <p:cNvSpPr/>
            <p:nvPr/>
          </p:nvSpPr>
          <p:spPr>
            <a:xfrm>
              <a:off x="782640" y="3157560"/>
              <a:ext cx="752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" name="직선 연결선 19"/>
            <p:cNvSpPr/>
            <p:nvPr/>
          </p:nvSpPr>
          <p:spPr>
            <a:xfrm>
              <a:off x="782640" y="4210200"/>
              <a:ext cx="752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" name="직선 연결선 20"/>
            <p:cNvSpPr/>
            <p:nvPr/>
          </p:nvSpPr>
          <p:spPr>
            <a:xfrm>
              <a:off x="782640" y="5261040"/>
              <a:ext cx="752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1" name="직선 연결선 21"/>
            <p:cNvSpPr/>
            <p:nvPr/>
          </p:nvSpPr>
          <p:spPr>
            <a:xfrm>
              <a:off x="782640" y="6319800"/>
              <a:ext cx="7523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52" name="Group 5"/>
          <p:cNvGrpSpPr/>
          <p:nvPr/>
        </p:nvGrpSpPr>
        <p:grpSpPr>
          <a:xfrm>
            <a:off x="4552920" y="727200"/>
            <a:ext cx="22320" cy="5565600"/>
            <a:chOff x="4552920" y="727200"/>
            <a:chExt cx="22320" cy="5565600"/>
          </a:xfrm>
        </p:grpSpPr>
        <p:grpSp>
          <p:nvGrpSpPr>
            <p:cNvPr id="53" name="Group 2"/>
            <p:cNvGrpSpPr/>
            <p:nvPr/>
          </p:nvGrpSpPr>
          <p:grpSpPr>
            <a:xfrm>
              <a:off x="4552920" y="727200"/>
              <a:ext cx="22320" cy="306000"/>
              <a:chOff x="4552920" y="727200"/>
              <a:chExt cx="22320" cy="306000"/>
            </a:xfrm>
          </p:grpSpPr>
          <p:sp>
            <p:nvSpPr>
              <p:cNvPr id="54" name="직선 연결선 29"/>
              <p:cNvSpPr/>
              <p:nvPr/>
            </p:nvSpPr>
            <p:spPr>
              <a:xfrm>
                <a:off x="4552920" y="727200"/>
                <a:ext cx="0" cy="30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5" name="직선 연결선 30"/>
              <p:cNvSpPr/>
              <p:nvPr/>
            </p:nvSpPr>
            <p:spPr>
              <a:xfrm>
                <a:off x="4575240" y="727200"/>
                <a:ext cx="0" cy="30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56" name="Group 36"/>
            <p:cNvGrpSpPr/>
            <p:nvPr/>
          </p:nvGrpSpPr>
          <p:grpSpPr>
            <a:xfrm>
              <a:off x="4552920" y="1077840"/>
              <a:ext cx="22320" cy="1008000"/>
              <a:chOff x="4552920" y="1077840"/>
              <a:chExt cx="22320" cy="1008000"/>
            </a:xfrm>
          </p:grpSpPr>
          <p:sp>
            <p:nvSpPr>
              <p:cNvPr id="57" name="직선 연결선 29"/>
              <p:cNvSpPr/>
              <p:nvPr/>
            </p:nvSpPr>
            <p:spPr>
              <a:xfrm>
                <a:off x="4552920" y="107784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8" name="직선 연결선 30"/>
              <p:cNvSpPr/>
              <p:nvPr/>
            </p:nvSpPr>
            <p:spPr>
              <a:xfrm>
                <a:off x="4575240" y="107784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59" name="Group 40"/>
            <p:cNvGrpSpPr/>
            <p:nvPr/>
          </p:nvGrpSpPr>
          <p:grpSpPr>
            <a:xfrm>
              <a:off x="4552920" y="2130120"/>
              <a:ext cx="22320" cy="1008000"/>
              <a:chOff x="4552920" y="2130120"/>
              <a:chExt cx="22320" cy="1008000"/>
            </a:xfrm>
          </p:grpSpPr>
          <p:sp>
            <p:nvSpPr>
              <p:cNvPr id="60" name="직선 연결선 29"/>
              <p:cNvSpPr/>
              <p:nvPr/>
            </p:nvSpPr>
            <p:spPr>
              <a:xfrm>
                <a:off x="4552920" y="21301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1" name="직선 연결선 30"/>
              <p:cNvSpPr/>
              <p:nvPr/>
            </p:nvSpPr>
            <p:spPr>
              <a:xfrm>
                <a:off x="4575240" y="21301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62" name="Group 45"/>
            <p:cNvGrpSpPr/>
            <p:nvPr/>
          </p:nvGrpSpPr>
          <p:grpSpPr>
            <a:xfrm>
              <a:off x="4552920" y="3179520"/>
              <a:ext cx="22320" cy="1008000"/>
              <a:chOff x="4552920" y="3179520"/>
              <a:chExt cx="22320" cy="1008000"/>
            </a:xfrm>
          </p:grpSpPr>
          <p:sp>
            <p:nvSpPr>
              <p:cNvPr id="63" name="직선 연결선 29"/>
              <p:cNvSpPr/>
              <p:nvPr/>
            </p:nvSpPr>
            <p:spPr>
              <a:xfrm>
                <a:off x="4552920" y="31795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4" name="직선 연결선 30"/>
              <p:cNvSpPr/>
              <p:nvPr/>
            </p:nvSpPr>
            <p:spPr>
              <a:xfrm>
                <a:off x="4575240" y="31795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65" name="Group 54"/>
            <p:cNvGrpSpPr/>
            <p:nvPr/>
          </p:nvGrpSpPr>
          <p:grpSpPr>
            <a:xfrm>
              <a:off x="4552920" y="4232520"/>
              <a:ext cx="22320" cy="1008000"/>
              <a:chOff x="4552920" y="4232520"/>
              <a:chExt cx="22320" cy="1008000"/>
            </a:xfrm>
          </p:grpSpPr>
          <p:sp>
            <p:nvSpPr>
              <p:cNvPr id="66" name="직선 연결선 29"/>
              <p:cNvSpPr/>
              <p:nvPr/>
            </p:nvSpPr>
            <p:spPr>
              <a:xfrm>
                <a:off x="4552920" y="42325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7" name="직선 연결선 30"/>
              <p:cNvSpPr/>
              <p:nvPr/>
            </p:nvSpPr>
            <p:spPr>
              <a:xfrm>
                <a:off x="4575240" y="42325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68" name="Group 57"/>
            <p:cNvGrpSpPr/>
            <p:nvPr/>
          </p:nvGrpSpPr>
          <p:grpSpPr>
            <a:xfrm>
              <a:off x="4552920" y="5284800"/>
              <a:ext cx="22320" cy="1008000"/>
              <a:chOff x="4552920" y="5284800"/>
              <a:chExt cx="22320" cy="1008000"/>
            </a:xfrm>
          </p:grpSpPr>
          <p:sp>
            <p:nvSpPr>
              <p:cNvPr id="69" name="직선 연결선 29"/>
              <p:cNvSpPr/>
              <p:nvPr/>
            </p:nvSpPr>
            <p:spPr>
              <a:xfrm>
                <a:off x="4552920" y="528480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0" name="직선 연결선 30"/>
              <p:cNvSpPr/>
              <p:nvPr/>
            </p:nvSpPr>
            <p:spPr>
              <a:xfrm>
                <a:off x="4575240" y="528480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graphicFrame>
        <p:nvGraphicFramePr>
          <p:cNvPr id="71" name=""/>
          <p:cNvGraphicFramePr/>
          <p:nvPr/>
        </p:nvGraphicFramePr>
        <p:xfrm>
          <a:off x="754200" y="703440"/>
          <a:ext cx="3973320" cy="5608440"/>
        </p:xfrm>
        <a:graphic>
          <a:graphicData uri="http://schemas.openxmlformats.org/drawingml/2006/table">
            <a:tbl>
              <a:tblPr/>
              <a:tblGrid>
                <a:gridCol w="949320"/>
                <a:gridCol w="895320"/>
                <a:gridCol w="320400"/>
                <a:gridCol w="320760"/>
                <a:gridCol w="322200"/>
                <a:gridCol w="1165320"/>
              </a:tblGrid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iru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oculum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       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288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PFU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/mouse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l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ea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ot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D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50</a:t>
                      </a:r>
                      <a:r>
                        <a:rPr b="1" lang="en-US" sz="1100" spc="-1" strike="noStrike" baseline="-25000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7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-14-2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MC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arent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17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U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19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708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lt;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U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580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2" name=""/>
          <p:cNvGraphicFramePr/>
          <p:nvPr/>
        </p:nvGraphicFramePr>
        <p:xfrm>
          <a:off x="4600440" y="703440"/>
          <a:ext cx="3946680" cy="5608440"/>
        </p:xfrm>
        <a:graphic>
          <a:graphicData uri="http://schemas.openxmlformats.org/drawingml/2006/table">
            <a:tbl>
              <a:tblPr/>
              <a:tblGrid>
                <a:gridCol w="943200"/>
                <a:gridCol w="888840"/>
                <a:gridCol w="319320"/>
                <a:gridCol w="318960"/>
                <a:gridCol w="318960"/>
                <a:gridCol w="1157400"/>
              </a:tblGrid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irus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oculum 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       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288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/mouse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l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ea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ot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D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50</a:t>
                      </a:r>
                      <a:r>
                        <a:rPr b="1" lang="en-US" sz="1100" spc="-1" strike="noStrike" baseline="-25000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215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U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987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U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6551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U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8588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3" name="Text Box 778"/>
          <p:cNvSpPr/>
          <p:nvPr/>
        </p:nvSpPr>
        <p:spPr>
          <a:xfrm>
            <a:off x="7277760" y="0"/>
            <a:ext cx="186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Table S2. Yun </a:t>
            </a:r>
            <a:r>
              <a:rPr b="0" i="1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et al</a:t>
            </a: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., 201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Rectangle 1"/>
          <p:cNvSpPr/>
          <p:nvPr/>
        </p:nvSpPr>
        <p:spPr>
          <a:xfrm>
            <a:off x="693720" y="439560"/>
            <a:ext cx="587700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Neurovirulence of SA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1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14-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MCV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its eight mutants in 3-week-old ICR mice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05T16:33:49Z</dcterms:created>
  <dc:creator>Youngmin Lee</dc:creator>
  <dc:description/>
  <dc:language>en-US</dc:language>
  <cp:lastModifiedBy>Young-Min Lee</cp:lastModifiedBy>
  <dcterms:modified xsi:type="dcterms:W3CDTF">2014-01-30T00:28:49Z</dcterms:modified>
  <cp:revision>102</cp:revision>
  <dc:subject/>
  <dc:title>PowerPoint 프레젠테이션</dc:title>
</cp:coreProperties>
</file>